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notesMasterIdLst>
    <p:notesMasterId r:id="rId4"/>
  </p:notesMasterIdLst>
  <p:sldIdLst>
    <p:sldId id="397" r:id="rId2"/>
    <p:sldId id="394" r:id="rId3"/>
  </p:sldIdLst>
  <p:sldSz cx="6408738" cy="7559675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1" userDrawn="1">
          <p15:clr>
            <a:srgbClr val="A4A3A4"/>
          </p15:clr>
        </p15:guide>
        <p15:guide id="2" pos="201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ye In" initials="A" lastIdx="0" clrIdx="0">
    <p:extLst>
      <p:ext uri="{19B8F6BF-5375-455C-9EA6-DF929625EA0E}">
        <p15:presenceInfo xmlns:p15="http://schemas.microsoft.com/office/powerpoint/2012/main" userId="Hye In" providerId="None"/>
      </p:ext>
    </p:extLst>
  </p:cmAuthor>
  <p:cmAuthor id="2" name="가혜인" initials="가" lastIdx="1" clrIdx="1">
    <p:extLst>
      <p:ext uri="{19B8F6BF-5375-455C-9EA6-DF929625EA0E}">
        <p15:presenceInfo xmlns:p15="http://schemas.microsoft.com/office/powerpoint/2012/main" userId="가혜인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F739"/>
    <a:srgbClr val="E6E6E6"/>
    <a:srgbClr val="A00499"/>
    <a:srgbClr val="FED6F6"/>
    <a:srgbClr val="F96BDB"/>
    <a:srgbClr val="FD99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53" autoAdjust="0"/>
    <p:restoredTop sz="96391" autoAdjust="0"/>
  </p:normalViewPr>
  <p:slideViewPr>
    <p:cSldViewPr snapToGrid="0" snapToObjects="1">
      <p:cViewPr varScale="1">
        <p:scale>
          <a:sx n="70" d="100"/>
          <a:sy n="70" d="100"/>
        </p:scale>
        <p:origin x="1014" y="60"/>
      </p:cViewPr>
      <p:guideLst>
        <p:guide orient="horz" pos="2381"/>
        <p:guide pos="2019"/>
      </p:guideLst>
    </p:cSldViewPr>
  </p:slid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7" y="9"/>
            <a:ext cx="2971800" cy="499013"/>
          </a:xfrm>
          <a:prstGeom prst="rect">
            <a:avLst/>
          </a:prstGeom>
        </p:spPr>
        <p:txBody>
          <a:bodyPr vert="horz" lIns="92017" tIns="46009" rIns="92017" bIns="46009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27" y="9"/>
            <a:ext cx="2971800" cy="499013"/>
          </a:xfrm>
          <a:prstGeom prst="rect">
            <a:avLst/>
          </a:prstGeom>
        </p:spPr>
        <p:txBody>
          <a:bodyPr vert="horz" lIns="92017" tIns="46009" rIns="92017" bIns="46009" rtlCol="0"/>
          <a:lstStyle>
            <a:lvl1pPr algn="r">
              <a:defRPr sz="1200"/>
            </a:lvl1pPr>
          </a:lstStyle>
          <a:p>
            <a:fld id="{A29B25EE-5E67-49D0-9324-54015195543F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5013" y="1241425"/>
            <a:ext cx="2847975" cy="3359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017" tIns="46009" rIns="92017" bIns="46009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1" y="4786367"/>
            <a:ext cx="5486400" cy="3916115"/>
          </a:xfrm>
          <a:prstGeom prst="rect">
            <a:avLst/>
          </a:prstGeom>
        </p:spPr>
        <p:txBody>
          <a:bodyPr vert="horz" lIns="92017" tIns="46009" rIns="92017" bIns="46009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7" y="9446681"/>
            <a:ext cx="2971800" cy="499012"/>
          </a:xfrm>
          <a:prstGeom prst="rect">
            <a:avLst/>
          </a:prstGeom>
        </p:spPr>
        <p:txBody>
          <a:bodyPr vert="horz" lIns="92017" tIns="46009" rIns="92017" bIns="46009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27" y="9446681"/>
            <a:ext cx="2971800" cy="499012"/>
          </a:xfrm>
          <a:prstGeom prst="rect">
            <a:avLst/>
          </a:prstGeom>
        </p:spPr>
        <p:txBody>
          <a:bodyPr vert="horz" lIns="92017" tIns="46009" rIns="92017" bIns="46009" rtlCol="0" anchor="b"/>
          <a:lstStyle>
            <a:lvl1pPr algn="r">
              <a:defRPr sz="1200"/>
            </a:lvl1pPr>
          </a:lstStyle>
          <a:p>
            <a:fld id="{87690746-2C55-4D67-ACF8-62BA61FD8F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22435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1pPr>
    <a:lvl2pPr marL="299283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2pPr>
    <a:lvl3pPr marL="598566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3pPr>
    <a:lvl4pPr marL="897849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4pPr>
    <a:lvl5pPr marL="1197132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5pPr>
    <a:lvl6pPr marL="1496416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6pPr>
    <a:lvl7pPr marL="1795699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7pPr>
    <a:lvl8pPr marL="2094982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8pPr>
    <a:lvl9pPr marL="2394265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656" y="1237197"/>
            <a:ext cx="5447427" cy="2631887"/>
          </a:xfrm>
        </p:spPr>
        <p:txBody>
          <a:bodyPr anchor="b"/>
          <a:lstStyle>
            <a:lvl1pPr algn="ctr">
              <a:defRPr sz="420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1092" y="3970580"/>
            <a:ext cx="4806554" cy="1825171"/>
          </a:xfrm>
        </p:spPr>
        <p:txBody>
          <a:bodyPr/>
          <a:lstStyle>
            <a:lvl1pPr marL="0" indent="0" algn="ctr">
              <a:buNone/>
              <a:defRPr sz="1682"/>
            </a:lvl1pPr>
            <a:lvl2pPr marL="320451" indent="0" algn="ctr">
              <a:buNone/>
              <a:defRPr sz="1402"/>
            </a:lvl2pPr>
            <a:lvl3pPr marL="640903" indent="0" algn="ctr">
              <a:buNone/>
              <a:defRPr sz="1262"/>
            </a:lvl3pPr>
            <a:lvl4pPr marL="961354" indent="0" algn="ctr">
              <a:buNone/>
              <a:defRPr sz="1121"/>
            </a:lvl4pPr>
            <a:lvl5pPr marL="1281806" indent="0" algn="ctr">
              <a:buNone/>
              <a:defRPr sz="1121"/>
            </a:lvl5pPr>
            <a:lvl6pPr marL="1602257" indent="0" algn="ctr">
              <a:buNone/>
              <a:defRPr sz="1121"/>
            </a:lvl6pPr>
            <a:lvl7pPr marL="1922709" indent="0" algn="ctr">
              <a:buNone/>
              <a:defRPr sz="1121"/>
            </a:lvl7pPr>
            <a:lvl8pPr marL="2243160" indent="0" algn="ctr">
              <a:buNone/>
              <a:defRPr sz="1121"/>
            </a:lvl8pPr>
            <a:lvl9pPr marL="2563612" indent="0" algn="ctr">
              <a:buNone/>
              <a:defRPr sz="1121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7410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1909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6254" y="402483"/>
            <a:ext cx="1381884" cy="640647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601" y="402483"/>
            <a:ext cx="4065543" cy="640647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625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6025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7263" y="1884671"/>
            <a:ext cx="5527537" cy="3144614"/>
          </a:xfrm>
        </p:spPr>
        <p:txBody>
          <a:bodyPr anchor="b"/>
          <a:lstStyle>
            <a:lvl1pPr>
              <a:defRPr sz="420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7263" y="5059035"/>
            <a:ext cx="5527537" cy="1653678"/>
          </a:xfrm>
        </p:spPr>
        <p:txBody>
          <a:bodyPr/>
          <a:lstStyle>
            <a:lvl1pPr marL="0" indent="0">
              <a:buNone/>
              <a:defRPr sz="1682">
                <a:solidFill>
                  <a:schemeClr val="tx1"/>
                </a:solidFill>
              </a:defRPr>
            </a:lvl1pPr>
            <a:lvl2pPr marL="320451" indent="0">
              <a:buNone/>
              <a:defRPr sz="1402">
                <a:solidFill>
                  <a:schemeClr val="tx1">
                    <a:tint val="75000"/>
                  </a:schemeClr>
                </a:solidFill>
              </a:defRPr>
            </a:lvl2pPr>
            <a:lvl3pPr marL="640903" indent="0">
              <a:buNone/>
              <a:defRPr sz="1262">
                <a:solidFill>
                  <a:schemeClr val="tx1">
                    <a:tint val="75000"/>
                  </a:schemeClr>
                </a:solidFill>
              </a:defRPr>
            </a:lvl3pPr>
            <a:lvl4pPr marL="961354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4pPr>
            <a:lvl5pPr marL="1281806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5pPr>
            <a:lvl6pPr marL="1602257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6pPr>
            <a:lvl7pPr marL="1922709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7pPr>
            <a:lvl8pPr marL="2243160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8pPr>
            <a:lvl9pPr marL="2563612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675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601" y="2012414"/>
            <a:ext cx="2723714" cy="479654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4423" y="2012414"/>
            <a:ext cx="2723714" cy="479654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0391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402484"/>
            <a:ext cx="5527537" cy="1461188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1436" y="1853171"/>
            <a:ext cx="2711196" cy="908210"/>
          </a:xfrm>
        </p:spPr>
        <p:txBody>
          <a:bodyPr anchor="b"/>
          <a:lstStyle>
            <a:lvl1pPr marL="0" indent="0">
              <a:buNone/>
              <a:defRPr sz="1682" b="1"/>
            </a:lvl1pPr>
            <a:lvl2pPr marL="320451" indent="0">
              <a:buNone/>
              <a:defRPr sz="1402" b="1"/>
            </a:lvl2pPr>
            <a:lvl3pPr marL="640903" indent="0">
              <a:buNone/>
              <a:defRPr sz="1262" b="1"/>
            </a:lvl3pPr>
            <a:lvl4pPr marL="961354" indent="0">
              <a:buNone/>
              <a:defRPr sz="1121" b="1"/>
            </a:lvl4pPr>
            <a:lvl5pPr marL="1281806" indent="0">
              <a:buNone/>
              <a:defRPr sz="1121" b="1"/>
            </a:lvl5pPr>
            <a:lvl6pPr marL="1602257" indent="0">
              <a:buNone/>
              <a:defRPr sz="1121" b="1"/>
            </a:lvl6pPr>
            <a:lvl7pPr marL="1922709" indent="0">
              <a:buNone/>
              <a:defRPr sz="1121" b="1"/>
            </a:lvl7pPr>
            <a:lvl8pPr marL="2243160" indent="0">
              <a:buNone/>
              <a:defRPr sz="1121" b="1"/>
            </a:lvl8pPr>
            <a:lvl9pPr marL="2563612" indent="0">
              <a:buNone/>
              <a:defRPr sz="1121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1436" y="2761381"/>
            <a:ext cx="2711196" cy="406157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4424" y="1853171"/>
            <a:ext cx="2724548" cy="908210"/>
          </a:xfrm>
        </p:spPr>
        <p:txBody>
          <a:bodyPr anchor="b"/>
          <a:lstStyle>
            <a:lvl1pPr marL="0" indent="0">
              <a:buNone/>
              <a:defRPr sz="1682" b="1"/>
            </a:lvl1pPr>
            <a:lvl2pPr marL="320451" indent="0">
              <a:buNone/>
              <a:defRPr sz="1402" b="1"/>
            </a:lvl2pPr>
            <a:lvl3pPr marL="640903" indent="0">
              <a:buNone/>
              <a:defRPr sz="1262" b="1"/>
            </a:lvl3pPr>
            <a:lvl4pPr marL="961354" indent="0">
              <a:buNone/>
              <a:defRPr sz="1121" b="1"/>
            </a:lvl4pPr>
            <a:lvl5pPr marL="1281806" indent="0">
              <a:buNone/>
              <a:defRPr sz="1121" b="1"/>
            </a:lvl5pPr>
            <a:lvl6pPr marL="1602257" indent="0">
              <a:buNone/>
              <a:defRPr sz="1121" b="1"/>
            </a:lvl6pPr>
            <a:lvl7pPr marL="1922709" indent="0">
              <a:buNone/>
              <a:defRPr sz="1121" b="1"/>
            </a:lvl7pPr>
            <a:lvl8pPr marL="2243160" indent="0">
              <a:buNone/>
              <a:defRPr sz="1121" b="1"/>
            </a:lvl8pPr>
            <a:lvl9pPr marL="2563612" indent="0">
              <a:buNone/>
              <a:defRPr sz="1121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4424" y="2761381"/>
            <a:ext cx="2724548" cy="406157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9626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3199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7233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503978"/>
            <a:ext cx="2066985" cy="1763924"/>
          </a:xfrm>
        </p:spPr>
        <p:txBody>
          <a:bodyPr anchor="b"/>
          <a:lstStyle>
            <a:lvl1pPr>
              <a:defRPr sz="2243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4548" y="1088455"/>
            <a:ext cx="3244424" cy="5372269"/>
          </a:xfrm>
        </p:spPr>
        <p:txBody>
          <a:bodyPr/>
          <a:lstStyle>
            <a:lvl1pPr>
              <a:defRPr sz="2243"/>
            </a:lvl1pPr>
            <a:lvl2pPr>
              <a:defRPr sz="1963"/>
            </a:lvl2pPr>
            <a:lvl3pPr>
              <a:defRPr sz="1682"/>
            </a:lvl3pPr>
            <a:lvl4pPr>
              <a:defRPr sz="1402"/>
            </a:lvl4pPr>
            <a:lvl5pPr>
              <a:defRPr sz="1402"/>
            </a:lvl5pPr>
            <a:lvl6pPr>
              <a:defRPr sz="1402"/>
            </a:lvl6pPr>
            <a:lvl7pPr>
              <a:defRPr sz="1402"/>
            </a:lvl7pPr>
            <a:lvl8pPr>
              <a:defRPr sz="1402"/>
            </a:lvl8pPr>
            <a:lvl9pPr>
              <a:defRPr sz="1402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1435" y="2267902"/>
            <a:ext cx="2066985" cy="4201570"/>
          </a:xfrm>
        </p:spPr>
        <p:txBody>
          <a:bodyPr/>
          <a:lstStyle>
            <a:lvl1pPr marL="0" indent="0">
              <a:buNone/>
              <a:defRPr sz="1121"/>
            </a:lvl1pPr>
            <a:lvl2pPr marL="320451" indent="0">
              <a:buNone/>
              <a:defRPr sz="981"/>
            </a:lvl2pPr>
            <a:lvl3pPr marL="640903" indent="0">
              <a:buNone/>
              <a:defRPr sz="841"/>
            </a:lvl3pPr>
            <a:lvl4pPr marL="961354" indent="0">
              <a:buNone/>
              <a:defRPr sz="701"/>
            </a:lvl4pPr>
            <a:lvl5pPr marL="1281806" indent="0">
              <a:buNone/>
              <a:defRPr sz="701"/>
            </a:lvl5pPr>
            <a:lvl6pPr marL="1602257" indent="0">
              <a:buNone/>
              <a:defRPr sz="701"/>
            </a:lvl6pPr>
            <a:lvl7pPr marL="1922709" indent="0">
              <a:buNone/>
              <a:defRPr sz="701"/>
            </a:lvl7pPr>
            <a:lvl8pPr marL="2243160" indent="0">
              <a:buNone/>
              <a:defRPr sz="701"/>
            </a:lvl8pPr>
            <a:lvl9pPr marL="2563612" indent="0">
              <a:buNone/>
              <a:defRPr sz="70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711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503978"/>
            <a:ext cx="2066985" cy="1763924"/>
          </a:xfrm>
        </p:spPr>
        <p:txBody>
          <a:bodyPr anchor="b"/>
          <a:lstStyle>
            <a:lvl1pPr>
              <a:defRPr sz="2243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4548" y="1088455"/>
            <a:ext cx="3244424" cy="5372269"/>
          </a:xfrm>
        </p:spPr>
        <p:txBody>
          <a:bodyPr anchor="t"/>
          <a:lstStyle>
            <a:lvl1pPr marL="0" indent="0">
              <a:buNone/>
              <a:defRPr sz="2243"/>
            </a:lvl1pPr>
            <a:lvl2pPr marL="320451" indent="0">
              <a:buNone/>
              <a:defRPr sz="1963"/>
            </a:lvl2pPr>
            <a:lvl3pPr marL="640903" indent="0">
              <a:buNone/>
              <a:defRPr sz="1682"/>
            </a:lvl3pPr>
            <a:lvl4pPr marL="961354" indent="0">
              <a:buNone/>
              <a:defRPr sz="1402"/>
            </a:lvl4pPr>
            <a:lvl5pPr marL="1281806" indent="0">
              <a:buNone/>
              <a:defRPr sz="1402"/>
            </a:lvl5pPr>
            <a:lvl6pPr marL="1602257" indent="0">
              <a:buNone/>
              <a:defRPr sz="1402"/>
            </a:lvl6pPr>
            <a:lvl7pPr marL="1922709" indent="0">
              <a:buNone/>
              <a:defRPr sz="1402"/>
            </a:lvl7pPr>
            <a:lvl8pPr marL="2243160" indent="0">
              <a:buNone/>
              <a:defRPr sz="1402"/>
            </a:lvl8pPr>
            <a:lvl9pPr marL="2563612" indent="0">
              <a:buNone/>
              <a:defRPr sz="1402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1435" y="2267902"/>
            <a:ext cx="2066985" cy="4201570"/>
          </a:xfrm>
        </p:spPr>
        <p:txBody>
          <a:bodyPr/>
          <a:lstStyle>
            <a:lvl1pPr marL="0" indent="0">
              <a:buNone/>
              <a:defRPr sz="1121"/>
            </a:lvl1pPr>
            <a:lvl2pPr marL="320451" indent="0">
              <a:buNone/>
              <a:defRPr sz="981"/>
            </a:lvl2pPr>
            <a:lvl3pPr marL="640903" indent="0">
              <a:buNone/>
              <a:defRPr sz="841"/>
            </a:lvl3pPr>
            <a:lvl4pPr marL="961354" indent="0">
              <a:buNone/>
              <a:defRPr sz="701"/>
            </a:lvl4pPr>
            <a:lvl5pPr marL="1281806" indent="0">
              <a:buNone/>
              <a:defRPr sz="701"/>
            </a:lvl5pPr>
            <a:lvl6pPr marL="1602257" indent="0">
              <a:buNone/>
              <a:defRPr sz="701"/>
            </a:lvl6pPr>
            <a:lvl7pPr marL="1922709" indent="0">
              <a:buNone/>
              <a:defRPr sz="701"/>
            </a:lvl7pPr>
            <a:lvl8pPr marL="2243160" indent="0">
              <a:buNone/>
              <a:defRPr sz="701"/>
            </a:lvl8pPr>
            <a:lvl9pPr marL="2563612" indent="0">
              <a:buNone/>
              <a:defRPr sz="70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4581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601" y="402484"/>
            <a:ext cx="5527537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601" y="2012414"/>
            <a:ext cx="5527537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601" y="7006700"/>
            <a:ext cx="1441966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927BB-49FC-4D42-9A1B-9F864BA2AAE7}" type="datetimeFigureOut">
              <a:rPr lang="ko-KR" altLang="en-US" smtClean="0"/>
              <a:t>2021-02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2895" y="7006700"/>
            <a:ext cx="2162949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6171" y="7006700"/>
            <a:ext cx="1441966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7059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40903" rtl="0" eaLnBrk="1" latinLnBrk="1" hangingPunct="1">
        <a:lnSpc>
          <a:spcPct val="90000"/>
        </a:lnSpc>
        <a:spcBef>
          <a:spcPct val="0"/>
        </a:spcBef>
        <a:buNone/>
        <a:defRPr sz="308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226" indent="-160226" algn="l" defTabSz="640903" rtl="0" eaLnBrk="1" latinLnBrk="1" hangingPunct="1">
        <a:lnSpc>
          <a:spcPct val="90000"/>
        </a:lnSpc>
        <a:spcBef>
          <a:spcPts val="701"/>
        </a:spcBef>
        <a:buFont typeface="Arial" panose="020B0604020202020204" pitchFamily="34" charset="0"/>
        <a:buChar char="•"/>
        <a:defRPr sz="1963" kern="1200">
          <a:solidFill>
            <a:schemeClr val="tx1"/>
          </a:solidFill>
          <a:latin typeface="+mn-lt"/>
          <a:ea typeface="+mn-ea"/>
          <a:cs typeface="+mn-cs"/>
        </a:defRPr>
      </a:lvl1pPr>
      <a:lvl2pPr marL="480677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2" kern="1200">
          <a:solidFill>
            <a:schemeClr val="tx1"/>
          </a:solidFill>
          <a:latin typeface="+mn-lt"/>
          <a:ea typeface="+mn-ea"/>
          <a:cs typeface="+mn-cs"/>
        </a:defRPr>
      </a:lvl2pPr>
      <a:lvl3pPr marL="801129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2" kern="1200">
          <a:solidFill>
            <a:schemeClr val="tx1"/>
          </a:solidFill>
          <a:latin typeface="+mn-lt"/>
          <a:ea typeface="+mn-ea"/>
          <a:cs typeface="+mn-cs"/>
        </a:defRPr>
      </a:lvl3pPr>
      <a:lvl4pPr marL="1121580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4pPr>
      <a:lvl5pPr marL="1442032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5pPr>
      <a:lvl6pPr marL="1762483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6pPr>
      <a:lvl7pPr marL="2082935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7pPr>
      <a:lvl8pPr marL="2403386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8pPr>
      <a:lvl9pPr marL="2723838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1pPr>
      <a:lvl2pPr marL="320451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2pPr>
      <a:lvl3pPr marL="640903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3pPr>
      <a:lvl4pPr marL="961354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4pPr>
      <a:lvl5pPr marL="1281806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5pPr>
      <a:lvl6pPr marL="1602257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6pPr>
      <a:lvl7pPr marL="1922709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7pPr>
      <a:lvl8pPr marL="2243160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8pPr>
      <a:lvl9pPr marL="2563612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tiff"/><Relationship Id="rId18" Type="http://schemas.microsoft.com/office/2007/relationships/hdphoto" Target="../media/hdphoto7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17" Type="http://schemas.openxmlformats.org/officeDocument/2006/relationships/image" Target="../media/image10.png"/><Relationship Id="rId2" Type="http://schemas.openxmlformats.org/officeDocument/2006/relationships/image" Target="../media/image1.tiff"/><Relationship Id="rId16" Type="http://schemas.microsoft.com/office/2007/relationships/hdphoto" Target="../media/hdphoto6.wdp"/><Relationship Id="rId20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5" Type="http://schemas.openxmlformats.org/officeDocument/2006/relationships/image" Target="../media/image9.png"/><Relationship Id="rId10" Type="http://schemas.microsoft.com/office/2007/relationships/hdphoto" Target="../media/hdphoto4.wdp"/><Relationship Id="rId19" Type="http://schemas.openxmlformats.org/officeDocument/2006/relationships/image" Target="../media/image11.png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3" Type="http://schemas.openxmlformats.org/officeDocument/2006/relationships/image" Target="../media/image14.png"/><Relationship Id="rId7" Type="http://schemas.microsoft.com/office/2007/relationships/hdphoto" Target="../media/hdphoto9.wdp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image" Target="../media/image20.tiff"/><Relationship Id="rId5" Type="http://schemas.openxmlformats.org/officeDocument/2006/relationships/image" Target="../media/image15.png"/><Relationship Id="rId10" Type="http://schemas.openxmlformats.org/officeDocument/2006/relationships/image" Target="../media/image19.tiff"/><Relationship Id="rId4" Type="http://schemas.microsoft.com/office/2007/relationships/hdphoto" Target="../media/hdphoto8.wdp"/><Relationship Id="rId9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3046" y="268856"/>
            <a:ext cx="11464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369292" y="2319943"/>
            <a:ext cx="3688886" cy="4384231"/>
            <a:chOff x="685800" y="559244"/>
            <a:chExt cx="3688886" cy="4384231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69" t="35577" r="22544" b="50512"/>
            <a:stretch/>
          </p:blipFill>
          <p:spPr>
            <a:xfrm>
              <a:off x="1249576" y="1133201"/>
              <a:ext cx="2145698" cy="434206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3383174" y="1231827"/>
              <a:ext cx="8775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H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그림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16" t="33467" r="20254" b="30452"/>
            <a:stretch/>
          </p:blipFill>
          <p:spPr>
            <a:xfrm>
              <a:off x="1253536" y="3691288"/>
              <a:ext cx="2207487" cy="1067256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2108" r="9159" b="5035"/>
            <a:stretch/>
          </p:blipFill>
          <p:spPr>
            <a:xfrm>
              <a:off x="1245863" y="2032066"/>
              <a:ext cx="2128901" cy="429672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37" t="32138" r="16575" b="54834"/>
            <a:stretch/>
          </p:blipFill>
          <p:spPr>
            <a:xfrm>
              <a:off x="1243897" y="1598691"/>
              <a:ext cx="2153057" cy="37779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3383174" y="1669109"/>
              <a:ext cx="8775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K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381494" y="2113503"/>
              <a:ext cx="8775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475059" y="723619"/>
              <a:ext cx="6400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IK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793503" y="718114"/>
              <a:ext cx="4872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Ctrl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직선 연결선 12"/>
            <p:cNvCxnSpPr/>
            <p:nvPr/>
          </p:nvCxnSpPr>
          <p:spPr>
            <a:xfrm>
              <a:off x="1628474" y="930256"/>
              <a:ext cx="74749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직선 연결선 13"/>
            <p:cNvCxnSpPr/>
            <p:nvPr/>
          </p:nvCxnSpPr>
          <p:spPr>
            <a:xfrm>
              <a:off x="2403265" y="930256"/>
              <a:ext cx="74749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3105064" y="909254"/>
              <a:ext cx="4552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Day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97295" y="933594"/>
              <a:ext cx="2958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985975" y="933594"/>
              <a:ext cx="2958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174654" y="933594"/>
              <a:ext cx="2958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직사각형 18"/>
            <p:cNvSpPr/>
            <p:nvPr/>
          </p:nvSpPr>
          <p:spPr>
            <a:xfrm>
              <a:off x="1624696" y="933594"/>
              <a:ext cx="26385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/>
              <a:r>
                <a:rPr lang="en-US" altLang="ko-KR" sz="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581993" y="925364"/>
              <a:ext cx="2958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750887" y="925364"/>
              <a:ext cx="2958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919781" y="925364"/>
              <a:ext cx="2958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직사각형 22"/>
            <p:cNvSpPr/>
            <p:nvPr/>
          </p:nvSpPr>
          <p:spPr>
            <a:xfrm>
              <a:off x="2419654" y="925364"/>
              <a:ext cx="26385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/>
              <a:r>
                <a:rPr lang="en-US" altLang="ko-KR" sz="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461023" y="4023833"/>
              <a:ext cx="8775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yoG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5" name="그림 24"/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40000" contrast="40000"/>
                      </a14:imgEffect>
                    </a14:imgLayer>
                  </a14:imgProps>
                </a:ext>
              </a:extLst>
            </a:blip>
            <a:srcRect l="987"/>
            <a:stretch/>
          </p:blipFill>
          <p:spPr>
            <a:xfrm>
              <a:off x="1249031" y="3285804"/>
              <a:ext cx="2211992" cy="348374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3497098" y="3303933"/>
              <a:ext cx="8775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K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596489" y="2878514"/>
              <a:ext cx="5879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IK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896142" y="2873009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altLang="ko-K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Ctrl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직선 연결선 28"/>
            <p:cNvCxnSpPr/>
            <p:nvPr/>
          </p:nvCxnSpPr>
          <p:spPr>
            <a:xfrm>
              <a:off x="1752299" y="3085151"/>
              <a:ext cx="68664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직선 연결선 29"/>
            <p:cNvCxnSpPr/>
            <p:nvPr/>
          </p:nvCxnSpPr>
          <p:spPr>
            <a:xfrm>
              <a:off x="2533441" y="3085151"/>
              <a:ext cx="68664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3235003" y="3095120"/>
              <a:ext cx="4181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Day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884353" y="3088489"/>
              <a:ext cx="271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073033" y="3088489"/>
              <a:ext cx="271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261712" y="3088489"/>
              <a:ext cx="271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직사각형 34"/>
            <p:cNvSpPr/>
            <p:nvPr/>
          </p:nvSpPr>
          <p:spPr>
            <a:xfrm>
              <a:off x="1709152" y="3088489"/>
              <a:ext cx="24237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/>
              <a:r>
                <a:rPr lang="en-US" altLang="ko-KR" sz="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675402" y="3080259"/>
              <a:ext cx="271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844296" y="3080259"/>
              <a:ext cx="271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013190" y="3080259"/>
              <a:ext cx="271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직사각형 38"/>
            <p:cNvSpPr/>
            <p:nvPr/>
          </p:nvSpPr>
          <p:spPr>
            <a:xfrm>
              <a:off x="2510461" y="3080259"/>
              <a:ext cx="24237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/>
              <a:r>
                <a:rPr lang="en-US" altLang="ko-KR" sz="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직선 연결선 39"/>
            <p:cNvCxnSpPr/>
            <p:nvPr/>
          </p:nvCxnSpPr>
          <p:spPr>
            <a:xfrm>
              <a:off x="1181992" y="1260656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798659" y="1116195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844793" y="939063"/>
              <a:ext cx="4735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184243" y="933111"/>
              <a:ext cx="4638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직선 연결선 43"/>
            <p:cNvCxnSpPr/>
            <p:nvPr/>
          </p:nvCxnSpPr>
          <p:spPr>
            <a:xfrm>
              <a:off x="1181992" y="1321161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798659" y="1217965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" name="직선 연결선 45"/>
            <p:cNvCxnSpPr/>
            <p:nvPr/>
          </p:nvCxnSpPr>
          <p:spPr>
            <a:xfrm>
              <a:off x="1180312" y="1411170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796979" y="1307974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직선 연결선 47"/>
            <p:cNvCxnSpPr/>
            <p:nvPr/>
          </p:nvCxnSpPr>
          <p:spPr>
            <a:xfrm>
              <a:off x="1181992" y="1473783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796979" y="1420388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직선 연결선 49"/>
            <p:cNvCxnSpPr/>
            <p:nvPr/>
          </p:nvCxnSpPr>
          <p:spPr>
            <a:xfrm>
              <a:off x="1181992" y="1743186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798659" y="1652694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직선 연결선 51"/>
            <p:cNvCxnSpPr/>
            <p:nvPr/>
          </p:nvCxnSpPr>
          <p:spPr>
            <a:xfrm>
              <a:off x="1183672" y="1858195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798659" y="1776770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직선 연결선 53"/>
            <p:cNvCxnSpPr/>
            <p:nvPr/>
          </p:nvCxnSpPr>
          <p:spPr>
            <a:xfrm>
              <a:off x="1181992" y="2177819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798659" y="2087327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직선 연결선 55"/>
            <p:cNvCxnSpPr/>
            <p:nvPr/>
          </p:nvCxnSpPr>
          <p:spPr>
            <a:xfrm>
              <a:off x="1183672" y="2292828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798659" y="2211403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직선 연결선 57"/>
            <p:cNvCxnSpPr/>
            <p:nvPr/>
          </p:nvCxnSpPr>
          <p:spPr>
            <a:xfrm>
              <a:off x="1211866" y="3929745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TextBox 58"/>
            <p:cNvSpPr txBox="1"/>
            <p:nvPr/>
          </p:nvSpPr>
          <p:spPr>
            <a:xfrm>
              <a:off x="828533" y="3839253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직선 연결선 59"/>
            <p:cNvCxnSpPr/>
            <p:nvPr/>
          </p:nvCxnSpPr>
          <p:spPr>
            <a:xfrm>
              <a:off x="1211866" y="4044754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TextBox 60"/>
            <p:cNvSpPr txBox="1"/>
            <p:nvPr/>
          </p:nvSpPr>
          <p:spPr>
            <a:xfrm>
              <a:off x="828533" y="3963329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직선 연결선 61"/>
            <p:cNvCxnSpPr/>
            <p:nvPr/>
          </p:nvCxnSpPr>
          <p:spPr>
            <a:xfrm>
              <a:off x="1207935" y="3405870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3" name="TextBox 62"/>
            <p:cNvSpPr txBox="1"/>
            <p:nvPr/>
          </p:nvSpPr>
          <p:spPr>
            <a:xfrm>
              <a:off x="824602" y="3315378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직선 연결선 63"/>
            <p:cNvCxnSpPr/>
            <p:nvPr/>
          </p:nvCxnSpPr>
          <p:spPr>
            <a:xfrm>
              <a:off x="1209615" y="3520879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824602" y="3439454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직선 연결선 65"/>
            <p:cNvCxnSpPr/>
            <p:nvPr/>
          </p:nvCxnSpPr>
          <p:spPr>
            <a:xfrm>
              <a:off x="1211866" y="4314555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직선 연결선 66"/>
            <p:cNvCxnSpPr/>
            <p:nvPr/>
          </p:nvCxnSpPr>
          <p:spPr>
            <a:xfrm>
              <a:off x="1211866" y="4516348"/>
              <a:ext cx="28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8" name="TextBox 67"/>
            <p:cNvSpPr txBox="1"/>
            <p:nvPr/>
          </p:nvSpPr>
          <p:spPr>
            <a:xfrm>
              <a:off x="824602" y="4235936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824602" y="4416210"/>
              <a:ext cx="4638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882787" y="3110368"/>
              <a:ext cx="4735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222237" y="3104416"/>
              <a:ext cx="4638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직사각형 71"/>
            <p:cNvSpPr/>
            <p:nvPr/>
          </p:nvSpPr>
          <p:spPr>
            <a:xfrm>
              <a:off x="685800" y="559244"/>
              <a:ext cx="3423336" cy="43842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73" name="TextBox 72"/>
          <p:cNvSpPr txBox="1"/>
          <p:nvPr/>
        </p:nvSpPr>
        <p:spPr>
          <a:xfrm>
            <a:off x="328108" y="2329694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E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6" name="그룹 115"/>
          <p:cNvGrpSpPr/>
          <p:nvPr/>
        </p:nvGrpSpPr>
        <p:grpSpPr>
          <a:xfrm>
            <a:off x="328108" y="791125"/>
            <a:ext cx="1278285" cy="1294705"/>
            <a:chOff x="223314" y="791125"/>
            <a:chExt cx="1278285" cy="1294705"/>
          </a:xfrm>
        </p:grpSpPr>
        <p:pic>
          <p:nvPicPr>
            <p:cNvPr id="74" name="그림 73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6236" t="-73812" r="49040" b="-122906"/>
            <a:stretch/>
          </p:blipFill>
          <p:spPr>
            <a:xfrm>
              <a:off x="312080" y="1567671"/>
              <a:ext cx="597175" cy="518159"/>
            </a:xfrm>
            <a:prstGeom prst="rect">
              <a:avLst/>
            </a:prstGeom>
            <a:ln w="12700">
              <a:noFill/>
            </a:ln>
          </p:spPr>
        </p:pic>
        <p:pic>
          <p:nvPicPr>
            <p:cNvPr id="75" name="그림 74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28" t="42006" r="51101" b="39887"/>
            <a:stretch/>
          </p:blipFill>
          <p:spPr>
            <a:xfrm>
              <a:off x="502701" y="1041703"/>
              <a:ext cx="429850" cy="565151"/>
            </a:xfrm>
            <a:prstGeom prst="rect">
              <a:avLst/>
            </a:prstGeom>
          </p:spPr>
        </p:pic>
        <p:sp>
          <p:nvSpPr>
            <p:cNvPr id="76" name="직사각형 75"/>
            <p:cNvSpPr/>
            <p:nvPr/>
          </p:nvSpPr>
          <p:spPr>
            <a:xfrm>
              <a:off x="559851" y="1415457"/>
              <a:ext cx="372700" cy="13645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952687" y="1400381"/>
              <a:ext cx="456871" cy="1915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K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직사각형 77"/>
            <p:cNvSpPr/>
            <p:nvPr/>
          </p:nvSpPr>
          <p:spPr>
            <a:xfrm>
              <a:off x="555840" y="1726417"/>
              <a:ext cx="372700" cy="13645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928540" y="1686924"/>
              <a:ext cx="5690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직사각형 79"/>
            <p:cNvSpPr/>
            <p:nvPr/>
          </p:nvSpPr>
          <p:spPr>
            <a:xfrm>
              <a:off x="289935" y="797058"/>
              <a:ext cx="1211664" cy="115144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23314" y="791125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A 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99" name="그림 98"/>
          <p:cNvPicPr>
            <a:picLocks noChangeAspect="1"/>
          </p:cNvPicPr>
          <p:nvPr/>
        </p:nvPicPr>
        <p:blipFill rotWithShape="1">
          <a:blip r:embed="rId14"/>
          <a:srcRect l="-3508" t="-61417" r="-98007" b="-203107"/>
          <a:stretch/>
        </p:blipFill>
        <p:spPr>
          <a:xfrm>
            <a:off x="4033087" y="5595693"/>
            <a:ext cx="1760558" cy="571869"/>
          </a:xfrm>
          <a:prstGeom prst="rect">
            <a:avLst/>
          </a:prstGeom>
          <a:ln w="12700">
            <a:noFill/>
          </a:ln>
        </p:spPr>
      </p:pic>
      <p:sp>
        <p:nvSpPr>
          <p:cNvPr id="100" name="TextBox 99"/>
          <p:cNvSpPr txBox="1"/>
          <p:nvPr/>
        </p:nvSpPr>
        <p:spPr>
          <a:xfrm>
            <a:off x="4954565" y="5645814"/>
            <a:ext cx="1163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935319" y="2445592"/>
            <a:ext cx="1163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Pax7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" name="그림 101"/>
          <p:cNvPicPr>
            <a:picLocks noChangeAspect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260" t="45590" r="57506" b="29563"/>
          <a:stretch/>
        </p:blipFill>
        <p:spPr>
          <a:xfrm>
            <a:off x="3965963" y="1042127"/>
            <a:ext cx="1006087" cy="775529"/>
          </a:xfrm>
          <a:prstGeom prst="rect">
            <a:avLst/>
          </a:prstGeom>
        </p:spPr>
      </p:pic>
      <p:sp>
        <p:nvSpPr>
          <p:cNvPr id="103" name="TextBox 102"/>
          <p:cNvSpPr txBox="1"/>
          <p:nvPr/>
        </p:nvSpPr>
        <p:spPr>
          <a:xfrm>
            <a:off x="4931994" y="1159216"/>
            <a:ext cx="1163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Myo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직사각형 103"/>
          <p:cNvSpPr/>
          <p:nvPr/>
        </p:nvSpPr>
        <p:spPr>
          <a:xfrm>
            <a:off x="4085492" y="1103002"/>
            <a:ext cx="392794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05" name="그림 104"/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9292" t="-484" r="19091" b="484"/>
          <a:stretch/>
        </p:blipFill>
        <p:spPr>
          <a:xfrm>
            <a:off x="4060904" y="3686721"/>
            <a:ext cx="881011" cy="655487"/>
          </a:xfrm>
          <a:prstGeom prst="rect">
            <a:avLst/>
          </a:prstGeom>
        </p:spPr>
      </p:pic>
      <p:sp>
        <p:nvSpPr>
          <p:cNvPr id="106" name="TextBox 105"/>
          <p:cNvSpPr txBox="1"/>
          <p:nvPr/>
        </p:nvSpPr>
        <p:spPr>
          <a:xfrm>
            <a:off x="4931994" y="3995490"/>
            <a:ext cx="1163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K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직사각형 106"/>
          <p:cNvSpPr/>
          <p:nvPr/>
        </p:nvSpPr>
        <p:spPr>
          <a:xfrm>
            <a:off x="4255983" y="4017224"/>
            <a:ext cx="346208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08" name="그림 107"/>
          <p:cNvPicPr>
            <a:picLocks noChangeAspect="1"/>
          </p:cNvPicPr>
          <p:nvPr/>
        </p:nvPicPr>
        <p:blipFill rotWithShape="1">
          <a:blip r:embed="rId19"/>
          <a:srcRect t="9229" r="10005"/>
          <a:stretch/>
        </p:blipFill>
        <p:spPr>
          <a:xfrm>
            <a:off x="4035258" y="1922545"/>
            <a:ext cx="900061" cy="1530331"/>
          </a:xfrm>
          <a:prstGeom prst="rect">
            <a:avLst/>
          </a:prstGeom>
        </p:spPr>
      </p:pic>
      <p:sp>
        <p:nvSpPr>
          <p:cNvPr id="109" name="직사각형 108"/>
          <p:cNvSpPr/>
          <p:nvPr/>
        </p:nvSpPr>
        <p:spPr>
          <a:xfrm>
            <a:off x="4139079" y="2450368"/>
            <a:ext cx="346210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0" name="직사각형 109"/>
          <p:cNvSpPr/>
          <p:nvPr/>
        </p:nvSpPr>
        <p:spPr>
          <a:xfrm>
            <a:off x="4054504" y="5666184"/>
            <a:ext cx="443028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1" name="직사각형 110"/>
          <p:cNvSpPr/>
          <p:nvPr/>
        </p:nvSpPr>
        <p:spPr>
          <a:xfrm>
            <a:off x="3965964" y="793082"/>
            <a:ext cx="1642916" cy="591109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12" name="그림 111"/>
          <p:cNvPicPr>
            <a:picLocks noChangeAspect="1"/>
          </p:cNvPicPr>
          <p:nvPr/>
        </p:nvPicPr>
        <p:blipFill rotWithShape="1">
          <a:blip r:embed="rId20"/>
          <a:srcRect r="68645"/>
          <a:stretch/>
        </p:blipFill>
        <p:spPr>
          <a:xfrm>
            <a:off x="4033087" y="4562350"/>
            <a:ext cx="917596" cy="955110"/>
          </a:xfrm>
          <a:prstGeom prst="rect">
            <a:avLst/>
          </a:prstGeom>
        </p:spPr>
      </p:pic>
      <p:sp>
        <p:nvSpPr>
          <p:cNvPr id="113" name="TextBox 112"/>
          <p:cNvSpPr txBox="1"/>
          <p:nvPr/>
        </p:nvSpPr>
        <p:spPr>
          <a:xfrm>
            <a:off x="4941915" y="4937220"/>
            <a:ext cx="1163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oG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직사각형 113"/>
          <p:cNvSpPr/>
          <p:nvPr/>
        </p:nvSpPr>
        <p:spPr>
          <a:xfrm>
            <a:off x="4121212" y="4915327"/>
            <a:ext cx="324441" cy="1337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5" name="TextBox 114"/>
          <p:cNvSpPr txBox="1"/>
          <p:nvPr/>
        </p:nvSpPr>
        <p:spPr>
          <a:xfrm>
            <a:off x="3957657" y="766330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C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직사각형 124"/>
          <p:cNvSpPr/>
          <p:nvPr/>
        </p:nvSpPr>
        <p:spPr>
          <a:xfrm>
            <a:off x="1257903" y="2969946"/>
            <a:ext cx="1559115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6" name="직사각형 125"/>
          <p:cNvSpPr/>
          <p:nvPr/>
        </p:nvSpPr>
        <p:spPr>
          <a:xfrm>
            <a:off x="1257903" y="3452876"/>
            <a:ext cx="1559115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7" name="직사각형 126"/>
          <p:cNvSpPr/>
          <p:nvPr/>
        </p:nvSpPr>
        <p:spPr>
          <a:xfrm>
            <a:off x="1286519" y="3882460"/>
            <a:ext cx="1559115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8" name="직사각형 127"/>
          <p:cNvSpPr/>
          <p:nvPr/>
        </p:nvSpPr>
        <p:spPr>
          <a:xfrm>
            <a:off x="1467579" y="5115937"/>
            <a:ext cx="1450915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9" name="직사각형 128"/>
          <p:cNvSpPr/>
          <p:nvPr/>
        </p:nvSpPr>
        <p:spPr>
          <a:xfrm>
            <a:off x="1480787" y="5796470"/>
            <a:ext cx="1452336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90891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그림 2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86" t="31028" r="50331" b="31537"/>
          <a:stretch/>
        </p:blipFill>
        <p:spPr>
          <a:xfrm>
            <a:off x="527211" y="4759265"/>
            <a:ext cx="1073151" cy="1168401"/>
          </a:xfrm>
          <a:prstGeom prst="rect">
            <a:avLst/>
          </a:prstGeom>
        </p:spPr>
      </p:pic>
      <p:pic>
        <p:nvPicPr>
          <p:cNvPr id="26" name="그림 25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400" t="48146" r="36930" b="39645"/>
          <a:stretch/>
        </p:blipFill>
        <p:spPr>
          <a:xfrm>
            <a:off x="3853031" y="4771965"/>
            <a:ext cx="1082040" cy="381000"/>
          </a:xfrm>
          <a:prstGeom prst="rect">
            <a:avLst/>
          </a:prstGeom>
        </p:spPr>
      </p:pic>
      <p:sp>
        <p:nvSpPr>
          <p:cNvPr id="29" name="직사각형 28"/>
          <p:cNvSpPr/>
          <p:nvPr/>
        </p:nvSpPr>
        <p:spPr>
          <a:xfrm>
            <a:off x="622480" y="4962465"/>
            <a:ext cx="792935" cy="1517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TextBox 30"/>
          <p:cNvSpPr txBox="1"/>
          <p:nvPr/>
        </p:nvSpPr>
        <p:spPr>
          <a:xfrm>
            <a:off x="1692488" y="4963600"/>
            <a:ext cx="4545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IK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그림 31"/>
          <p:cNvPicPr>
            <a:picLocks noChangeAspect="1"/>
          </p:cNvPicPr>
          <p:nvPr/>
        </p:nvPicPr>
        <p:blipFill rotWithShape="1">
          <a:blip r:embed="rId5"/>
          <a:srcRect t="32335" r="9576" b="1192"/>
          <a:stretch/>
        </p:blipFill>
        <p:spPr>
          <a:xfrm>
            <a:off x="2239126" y="4759265"/>
            <a:ext cx="1159394" cy="1168401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3398520" y="5196602"/>
            <a:ext cx="4545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x7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직사각형 33"/>
          <p:cNvSpPr/>
          <p:nvPr/>
        </p:nvSpPr>
        <p:spPr>
          <a:xfrm>
            <a:off x="2236993" y="5191704"/>
            <a:ext cx="955787" cy="2203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" name="TextBox 34"/>
          <p:cNvSpPr txBox="1"/>
          <p:nvPr/>
        </p:nvSpPr>
        <p:spPr>
          <a:xfrm>
            <a:off x="4909116" y="4791060"/>
            <a:ext cx="5880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o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83923" y="4470274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직사각형 36"/>
          <p:cNvSpPr/>
          <p:nvPr/>
        </p:nvSpPr>
        <p:spPr>
          <a:xfrm>
            <a:off x="420646" y="4450081"/>
            <a:ext cx="5210534" cy="15715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8" name="직사각형 37"/>
          <p:cNvSpPr/>
          <p:nvPr/>
        </p:nvSpPr>
        <p:spPr>
          <a:xfrm>
            <a:off x="4031136" y="4765997"/>
            <a:ext cx="834660" cy="2203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39" name="그림 38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376" t="29400" r="39751" b="54324"/>
          <a:stretch/>
        </p:blipFill>
        <p:spPr>
          <a:xfrm>
            <a:off x="601243" y="2747086"/>
            <a:ext cx="869951" cy="508001"/>
          </a:xfrm>
          <a:prstGeom prst="rect">
            <a:avLst/>
          </a:prstGeom>
        </p:spPr>
      </p:pic>
      <p:pic>
        <p:nvPicPr>
          <p:cNvPr id="40" name="그림 3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67" t="41048" r="43261" b="45371"/>
          <a:stretch/>
        </p:blipFill>
        <p:spPr>
          <a:xfrm>
            <a:off x="603442" y="2044385"/>
            <a:ext cx="905668" cy="520078"/>
          </a:xfrm>
          <a:prstGeom prst="rect">
            <a:avLst/>
          </a:prstGeom>
        </p:spPr>
      </p:pic>
      <p:pic>
        <p:nvPicPr>
          <p:cNvPr id="41" name="그림 4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67" t="44863" r="36292" b="38447"/>
          <a:stretch/>
        </p:blipFill>
        <p:spPr>
          <a:xfrm>
            <a:off x="603442" y="1436541"/>
            <a:ext cx="905669" cy="520926"/>
          </a:xfrm>
          <a:prstGeom prst="rect">
            <a:avLst/>
          </a:prstGeom>
        </p:spPr>
      </p:pic>
      <p:sp>
        <p:nvSpPr>
          <p:cNvPr id="42" name="직사각형 41"/>
          <p:cNvSpPr/>
          <p:nvPr/>
        </p:nvSpPr>
        <p:spPr>
          <a:xfrm>
            <a:off x="693131" y="1725719"/>
            <a:ext cx="695269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3" name="TextBox 42"/>
          <p:cNvSpPr txBox="1"/>
          <p:nvPr/>
        </p:nvSpPr>
        <p:spPr>
          <a:xfrm>
            <a:off x="1509111" y="1631841"/>
            <a:ext cx="1163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K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509111" y="2162416"/>
            <a:ext cx="1163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직사각형 44"/>
          <p:cNvSpPr/>
          <p:nvPr/>
        </p:nvSpPr>
        <p:spPr>
          <a:xfrm>
            <a:off x="684192" y="2277998"/>
            <a:ext cx="824917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6" name="직사각형 45"/>
          <p:cNvSpPr/>
          <p:nvPr/>
        </p:nvSpPr>
        <p:spPr>
          <a:xfrm>
            <a:off x="611959" y="2865273"/>
            <a:ext cx="824917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7" name="TextBox 46"/>
          <p:cNvSpPr txBox="1"/>
          <p:nvPr/>
        </p:nvSpPr>
        <p:spPr>
          <a:xfrm>
            <a:off x="1509109" y="2824406"/>
            <a:ext cx="464292" cy="2052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그림 47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17" t="41201" r="41862" b="32351"/>
          <a:stretch/>
        </p:blipFill>
        <p:spPr>
          <a:xfrm>
            <a:off x="2076672" y="1429532"/>
            <a:ext cx="876010" cy="933453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>
            <a:off x="2952682" y="1637065"/>
            <a:ext cx="988262" cy="2052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leaved caspase-9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그림 4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44" t="35943" r="36207" b="28031"/>
          <a:stretch/>
        </p:blipFill>
        <p:spPr>
          <a:xfrm>
            <a:off x="2064205" y="2480230"/>
            <a:ext cx="900944" cy="1003376"/>
          </a:xfrm>
          <a:prstGeom prst="rect">
            <a:avLst/>
          </a:prstGeom>
        </p:spPr>
      </p:pic>
      <p:sp>
        <p:nvSpPr>
          <p:cNvPr id="51" name="TextBox 50"/>
          <p:cNvSpPr txBox="1"/>
          <p:nvPr/>
        </p:nvSpPr>
        <p:spPr>
          <a:xfrm>
            <a:off x="3006597" y="2706636"/>
            <a:ext cx="11095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leaved 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17500" y="1160860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C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직사각형 52"/>
          <p:cNvSpPr/>
          <p:nvPr/>
        </p:nvSpPr>
        <p:spPr>
          <a:xfrm>
            <a:off x="2117089" y="2766474"/>
            <a:ext cx="824917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4" name="직사각형 53"/>
          <p:cNvSpPr/>
          <p:nvPr/>
        </p:nvSpPr>
        <p:spPr>
          <a:xfrm>
            <a:off x="2132315" y="1894692"/>
            <a:ext cx="809691" cy="2154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5" name="직사각형 54"/>
          <p:cNvSpPr/>
          <p:nvPr/>
        </p:nvSpPr>
        <p:spPr>
          <a:xfrm>
            <a:off x="420646" y="1160931"/>
            <a:ext cx="3736997" cy="23968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9245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798</TotalTime>
  <Words>92</Words>
  <Application>Microsoft Office PowerPoint</Application>
  <PresentationFormat>사용자 지정</PresentationFormat>
  <Paragraphs>66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가혜인</cp:lastModifiedBy>
  <cp:revision>1251</cp:revision>
  <cp:lastPrinted>2020-08-25T05:02:13Z</cp:lastPrinted>
  <dcterms:created xsi:type="dcterms:W3CDTF">2017-01-17T09:29:41Z</dcterms:created>
  <dcterms:modified xsi:type="dcterms:W3CDTF">2021-02-09T10:05:17Z</dcterms:modified>
</cp:coreProperties>
</file>